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4" d="100"/>
          <a:sy n="84" d="100"/>
        </p:scale>
        <p:origin x="581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ocuments\Stick%202019\Fragebogen\neusubgruppen%201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ocuments\Stick%202019\Fragebogen\neusubgruppen%201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ocuments\Stick%202019\Fragebogen\neusubgruppen%201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400" b="0" i="0" baseline="0">
                <a:effectLst/>
              </a:rPr>
              <a:t>Subgroup 0-17 (young) and ≥ 18 (old) years of age</a:t>
            </a:r>
            <a:endParaRPr lang="en-US" sz="1050">
              <a:effectLst/>
            </a:endParaRPr>
          </a:p>
          <a:p>
            <a:pPr>
              <a:defRPr sz="1200"/>
            </a:pPr>
            <a:r>
              <a:rPr lang="en-US" sz="1200" baseline="0"/>
              <a:t> - general health, quality of life, knowledge about clinical studies</a:t>
            </a:r>
            <a:endParaRPr lang="en-US" sz="1200"/>
          </a:p>
        </c:rich>
      </c:tx>
      <c:layout>
        <c:manualLayout>
          <c:xMode val="edge"/>
          <c:yMode val="edge"/>
          <c:x val="0.2147765199022707"/>
          <c:y val="1.030346127338611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48802808519454871"/>
          <c:y val="0.11414817155463861"/>
          <c:w val="0.41794470245166859"/>
          <c:h val="0.82498315893904117"/>
        </c:manualLayout>
      </c:layout>
      <c:barChart>
        <c:barDir val="bar"/>
        <c:grouping val="percentStacked"/>
        <c:varyColors val="0"/>
        <c:ser>
          <c:idx val="0"/>
          <c:order val="0"/>
          <c:tx>
            <c:v>1 - very poor/low</c:v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dLbls>
            <c:dLbl>
              <c:idx val="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47FC-4413-8773-059E1E8C12BC}"/>
                </c:ext>
              </c:extLst>
            </c:dLbl>
            <c:dLbl>
              <c:idx val="6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47FC-4413-8773-059E1E8C12BC}"/>
                </c:ext>
              </c:extLst>
            </c:dLbl>
            <c:dLbl>
              <c:idx val="18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47FC-4413-8773-059E1E8C12BC}"/>
                </c:ext>
              </c:extLst>
            </c:dLbl>
            <c:dLbl>
              <c:idx val="21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47FC-4413-8773-059E1E8C12BC}"/>
                </c:ext>
              </c:extLst>
            </c:dLbl>
            <c:dLbl>
              <c:idx val="27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4-47FC-4413-8773-059E1E8C12BC}"/>
                </c:ext>
              </c:extLst>
            </c:dLbl>
            <c:dLbl>
              <c:idx val="3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47FC-4413-8773-059E1E8C12BC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50" b="1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ubgroup young old'!$D$20:$AI$20</c:f>
              <c:strCache>
                <c:ptCount val="32"/>
                <c:pt idx="0">
                  <c:v>Quality of Life in the past 12 months         &lt; 18</c:v>
                </c:pt>
                <c:pt idx="1">
                  <c:v>≥18a</c:v>
                </c:pt>
                <c:pt idx="3">
                  <c:v>Health status in the past 12 months      &lt; 18</c:v>
                </c:pt>
                <c:pt idx="4">
                  <c:v>≥18a</c:v>
                </c:pt>
                <c:pt idx="6">
                  <c:v>Medical care outside EB House Austria in the past 12 months        &lt; 18</c:v>
                </c:pt>
                <c:pt idx="7">
                  <c:v>≥18a</c:v>
                </c:pt>
                <c:pt idx="9">
                  <c:v>Medical care within the EB House Austria in the past 12 months      &lt; 18</c:v>
                </c:pt>
                <c:pt idx="10">
                  <c:v>≥18a</c:v>
                </c:pt>
                <c:pt idx="12">
                  <c:v>Knowledge about worldwide clinical trials for EB       &lt; 18</c:v>
                </c:pt>
                <c:pt idx="13">
                  <c:v>≥18a</c:v>
                </c:pt>
                <c:pt idx="15">
                  <c:v>Knowledge about clinical trials in the EB House Austria       &lt; 18</c:v>
                </c:pt>
                <c:pt idx="16">
                  <c:v>≥18a</c:v>
                </c:pt>
                <c:pt idx="18">
                  <c:v>Desire for more information about clinical studies       &lt; 18</c:v>
                </c:pt>
                <c:pt idx="19">
                  <c:v>≥18a</c:v>
                </c:pt>
                <c:pt idx="21">
                  <c:v>Willingness to persuade other patients to participate in a clinical trial       &lt; 18</c:v>
                </c:pt>
                <c:pt idx="22">
                  <c:v>≥18a</c:v>
                </c:pt>
                <c:pt idx="24">
                  <c:v>*Willingness to participate in clinical studies       &lt; 18</c:v>
                </c:pt>
                <c:pt idx="25">
                  <c:v>≥18a</c:v>
                </c:pt>
                <c:pt idx="27">
                  <c:v>*Desire for better treatment options       &lt; 18</c:v>
                </c:pt>
                <c:pt idx="28">
                  <c:v>≥18a</c:v>
                </c:pt>
                <c:pt idx="30">
                  <c:v>Hope for improved QoL within the next 5-10 years through new therapies      &lt; 18</c:v>
                </c:pt>
                <c:pt idx="31">
                  <c:v>≥18a</c:v>
                </c:pt>
              </c:strCache>
            </c:strRef>
          </c:cat>
          <c:val>
            <c:numRef>
              <c:f>'subgroup young old'!$D$21:$AI$21</c:f>
              <c:numCache>
                <c:formatCode>General</c:formatCode>
                <c:ptCount val="32"/>
                <c:pt idx="0">
                  <c:v>0</c:v>
                </c:pt>
                <c:pt idx="7">
                  <c:v>1</c:v>
                </c:pt>
                <c:pt idx="12">
                  <c:v>1</c:v>
                </c:pt>
                <c:pt idx="13">
                  <c:v>1</c:v>
                </c:pt>
                <c:pt idx="15">
                  <c:v>2</c:v>
                </c:pt>
                <c:pt idx="16">
                  <c:v>1</c:v>
                </c:pt>
                <c:pt idx="19">
                  <c:v>1</c:v>
                </c:pt>
                <c:pt idx="22">
                  <c:v>2</c:v>
                </c:pt>
                <c:pt idx="24">
                  <c:v>1</c:v>
                </c:pt>
                <c:pt idx="25">
                  <c:v>5</c:v>
                </c:pt>
                <c:pt idx="28">
                  <c:v>1</c:v>
                </c:pt>
                <c:pt idx="31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47FC-4413-8773-059E1E8C12BC}"/>
            </c:ext>
          </c:extLst>
        </c:ser>
        <c:ser>
          <c:idx val="1"/>
          <c:order val="1"/>
          <c:tx>
            <c:v>2</c:v>
          </c:tx>
          <c:spPr>
            <a:solidFill>
              <a:srgbClr val="F63B00"/>
            </a:solidFill>
            <a:ln>
              <a:noFill/>
            </a:ln>
            <a:effectLst/>
          </c:spPr>
          <c:invertIfNegative val="0"/>
          <c:dLbls>
            <c:dLbl>
              <c:idx val="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47FC-4413-8773-059E1E8C12BC}"/>
                </c:ext>
              </c:extLst>
            </c:dLbl>
            <c:dLbl>
              <c:idx val="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8-47FC-4413-8773-059E1E8C12BC}"/>
                </c:ext>
              </c:extLst>
            </c:dLbl>
            <c:dLbl>
              <c:idx val="6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47FC-4413-8773-059E1E8C12BC}"/>
                </c:ext>
              </c:extLst>
            </c:dLbl>
            <c:dLbl>
              <c:idx val="24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A-47FC-4413-8773-059E1E8C12BC}"/>
                </c:ext>
              </c:extLst>
            </c:dLbl>
            <c:dLbl>
              <c:idx val="31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47FC-4413-8773-059E1E8C12BC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50" b="1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ubgroup young old'!$D$20:$AI$20</c:f>
              <c:strCache>
                <c:ptCount val="32"/>
                <c:pt idx="0">
                  <c:v>Quality of Life in the past 12 months         &lt; 18</c:v>
                </c:pt>
                <c:pt idx="1">
                  <c:v>≥18a</c:v>
                </c:pt>
                <c:pt idx="3">
                  <c:v>Health status in the past 12 months      &lt; 18</c:v>
                </c:pt>
                <c:pt idx="4">
                  <c:v>≥18a</c:v>
                </c:pt>
                <c:pt idx="6">
                  <c:v>Medical care outside EB House Austria in the past 12 months        &lt; 18</c:v>
                </c:pt>
                <c:pt idx="7">
                  <c:v>≥18a</c:v>
                </c:pt>
                <c:pt idx="9">
                  <c:v>Medical care within the EB House Austria in the past 12 months      &lt; 18</c:v>
                </c:pt>
                <c:pt idx="10">
                  <c:v>≥18a</c:v>
                </c:pt>
                <c:pt idx="12">
                  <c:v>Knowledge about worldwide clinical trials for EB       &lt; 18</c:v>
                </c:pt>
                <c:pt idx="13">
                  <c:v>≥18a</c:v>
                </c:pt>
                <c:pt idx="15">
                  <c:v>Knowledge about clinical trials in the EB House Austria       &lt; 18</c:v>
                </c:pt>
                <c:pt idx="16">
                  <c:v>≥18a</c:v>
                </c:pt>
                <c:pt idx="18">
                  <c:v>Desire for more information about clinical studies       &lt; 18</c:v>
                </c:pt>
                <c:pt idx="19">
                  <c:v>≥18a</c:v>
                </c:pt>
                <c:pt idx="21">
                  <c:v>Willingness to persuade other patients to participate in a clinical trial       &lt; 18</c:v>
                </c:pt>
                <c:pt idx="22">
                  <c:v>≥18a</c:v>
                </c:pt>
                <c:pt idx="24">
                  <c:v>*Willingness to participate in clinical studies       &lt; 18</c:v>
                </c:pt>
                <c:pt idx="25">
                  <c:v>≥18a</c:v>
                </c:pt>
                <c:pt idx="27">
                  <c:v>*Desire for better treatment options       &lt; 18</c:v>
                </c:pt>
                <c:pt idx="28">
                  <c:v>≥18a</c:v>
                </c:pt>
                <c:pt idx="30">
                  <c:v>Hope for improved QoL within the next 5-10 years through new therapies      &lt; 18</c:v>
                </c:pt>
                <c:pt idx="31">
                  <c:v>≥18a</c:v>
                </c:pt>
              </c:strCache>
            </c:strRef>
          </c:cat>
          <c:val>
            <c:numRef>
              <c:f>'subgroup young old'!$D$22:$AI$22</c:f>
              <c:numCache>
                <c:formatCode>###0</c:formatCode>
                <c:ptCount val="32"/>
                <c:pt idx="1">
                  <c:v>1</c:v>
                </c:pt>
                <c:pt idx="4">
                  <c:v>1</c:v>
                </c:pt>
                <c:pt idx="7" formatCode="General">
                  <c:v>2</c:v>
                </c:pt>
                <c:pt idx="12" formatCode="General">
                  <c:v>1</c:v>
                </c:pt>
                <c:pt idx="13" formatCode="General">
                  <c:v>4</c:v>
                </c:pt>
                <c:pt idx="15" formatCode="General">
                  <c:v>1</c:v>
                </c:pt>
                <c:pt idx="16" formatCode="General">
                  <c:v>2</c:v>
                </c:pt>
                <c:pt idx="18" formatCode="General">
                  <c:v>1</c:v>
                </c:pt>
                <c:pt idx="19" formatCode="General">
                  <c:v>2</c:v>
                </c:pt>
                <c:pt idx="21" formatCode="General">
                  <c:v>1</c:v>
                </c:pt>
                <c:pt idx="22" formatCode="General">
                  <c:v>1</c:v>
                </c:pt>
                <c:pt idx="25" formatCode="General">
                  <c:v>3</c:v>
                </c:pt>
                <c:pt idx="27" formatCode="General">
                  <c:v>1</c:v>
                </c:pt>
                <c:pt idx="28" formatCode="General">
                  <c:v>2</c:v>
                </c:pt>
                <c:pt idx="30" formatCode="General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47FC-4413-8773-059E1E8C12BC}"/>
            </c:ext>
          </c:extLst>
        </c:ser>
        <c:ser>
          <c:idx val="2"/>
          <c:order val="2"/>
          <c:tx>
            <c:v>3</c:v>
          </c:tx>
          <c:spPr>
            <a:solidFill>
              <a:schemeClr val="bg1">
                <a:lumMod val="85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1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D-47FC-4413-8773-059E1E8C12BC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5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ubgroup young old'!$D$20:$AI$20</c:f>
              <c:strCache>
                <c:ptCount val="32"/>
                <c:pt idx="0">
                  <c:v>Quality of Life in the past 12 months         &lt; 18</c:v>
                </c:pt>
                <c:pt idx="1">
                  <c:v>≥18a</c:v>
                </c:pt>
                <c:pt idx="3">
                  <c:v>Health status in the past 12 months      &lt; 18</c:v>
                </c:pt>
                <c:pt idx="4">
                  <c:v>≥18a</c:v>
                </c:pt>
                <c:pt idx="6">
                  <c:v>Medical care outside EB House Austria in the past 12 months        &lt; 18</c:v>
                </c:pt>
                <c:pt idx="7">
                  <c:v>≥18a</c:v>
                </c:pt>
                <c:pt idx="9">
                  <c:v>Medical care within the EB House Austria in the past 12 months      &lt; 18</c:v>
                </c:pt>
                <c:pt idx="10">
                  <c:v>≥18a</c:v>
                </c:pt>
                <c:pt idx="12">
                  <c:v>Knowledge about worldwide clinical trials for EB       &lt; 18</c:v>
                </c:pt>
                <c:pt idx="13">
                  <c:v>≥18a</c:v>
                </c:pt>
                <c:pt idx="15">
                  <c:v>Knowledge about clinical trials in the EB House Austria       &lt; 18</c:v>
                </c:pt>
                <c:pt idx="16">
                  <c:v>≥18a</c:v>
                </c:pt>
                <c:pt idx="18">
                  <c:v>Desire for more information about clinical studies       &lt; 18</c:v>
                </c:pt>
                <c:pt idx="19">
                  <c:v>≥18a</c:v>
                </c:pt>
                <c:pt idx="21">
                  <c:v>Willingness to persuade other patients to participate in a clinical trial       &lt; 18</c:v>
                </c:pt>
                <c:pt idx="22">
                  <c:v>≥18a</c:v>
                </c:pt>
                <c:pt idx="24">
                  <c:v>*Willingness to participate in clinical studies       &lt; 18</c:v>
                </c:pt>
                <c:pt idx="25">
                  <c:v>≥18a</c:v>
                </c:pt>
                <c:pt idx="27">
                  <c:v>*Desire for better treatment options       &lt; 18</c:v>
                </c:pt>
                <c:pt idx="28">
                  <c:v>≥18a</c:v>
                </c:pt>
                <c:pt idx="30">
                  <c:v>Hope for improved QoL within the next 5-10 years through new therapies      &lt; 18</c:v>
                </c:pt>
                <c:pt idx="31">
                  <c:v>≥18a</c:v>
                </c:pt>
              </c:strCache>
            </c:strRef>
          </c:cat>
          <c:val>
            <c:numRef>
              <c:f>'subgroup young old'!$D$23:$AI$23</c:f>
              <c:numCache>
                <c:formatCode>###0</c:formatCode>
                <c:ptCount val="32"/>
                <c:pt idx="0">
                  <c:v>2</c:v>
                </c:pt>
                <c:pt idx="1">
                  <c:v>3</c:v>
                </c:pt>
                <c:pt idx="3">
                  <c:v>2</c:v>
                </c:pt>
                <c:pt idx="4">
                  <c:v>7</c:v>
                </c:pt>
                <c:pt idx="6" formatCode="General">
                  <c:v>3</c:v>
                </c:pt>
                <c:pt idx="7" formatCode="General">
                  <c:v>3</c:v>
                </c:pt>
                <c:pt idx="9" formatCode="General">
                  <c:v>1</c:v>
                </c:pt>
                <c:pt idx="12" formatCode="General">
                  <c:v>6</c:v>
                </c:pt>
                <c:pt idx="13" formatCode="General">
                  <c:v>2</c:v>
                </c:pt>
                <c:pt idx="15" formatCode="General">
                  <c:v>3</c:v>
                </c:pt>
                <c:pt idx="16" formatCode="General">
                  <c:v>7</c:v>
                </c:pt>
                <c:pt idx="18" formatCode="General">
                  <c:v>2</c:v>
                </c:pt>
                <c:pt idx="19" formatCode="General">
                  <c:v>3</c:v>
                </c:pt>
                <c:pt idx="21" formatCode="General">
                  <c:v>3</c:v>
                </c:pt>
                <c:pt idx="22" formatCode="General">
                  <c:v>6</c:v>
                </c:pt>
                <c:pt idx="24" formatCode="General">
                  <c:v>2</c:v>
                </c:pt>
                <c:pt idx="25" formatCode="General">
                  <c:v>2</c:v>
                </c:pt>
                <c:pt idx="27" formatCode="General">
                  <c:v>2</c:v>
                </c:pt>
                <c:pt idx="28" formatCode="General">
                  <c:v>8</c:v>
                </c:pt>
                <c:pt idx="30" formatCode="General">
                  <c:v>2</c:v>
                </c:pt>
                <c:pt idx="31" formatCode="General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47FC-4413-8773-059E1E8C12BC}"/>
            </c:ext>
          </c:extLst>
        </c:ser>
        <c:ser>
          <c:idx val="3"/>
          <c:order val="3"/>
          <c:tx>
            <c:v>4</c:v>
          </c:tx>
          <c:spPr>
            <a:solidFill>
              <a:srgbClr val="83BD5B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50" b="1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ubgroup young old'!$D$20:$AI$20</c:f>
              <c:strCache>
                <c:ptCount val="32"/>
                <c:pt idx="0">
                  <c:v>Quality of Life in the past 12 months         &lt; 18</c:v>
                </c:pt>
                <c:pt idx="1">
                  <c:v>≥18a</c:v>
                </c:pt>
                <c:pt idx="3">
                  <c:v>Health status in the past 12 months      &lt; 18</c:v>
                </c:pt>
                <c:pt idx="4">
                  <c:v>≥18a</c:v>
                </c:pt>
                <c:pt idx="6">
                  <c:v>Medical care outside EB House Austria in the past 12 months        &lt; 18</c:v>
                </c:pt>
                <c:pt idx="7">
                  <c:v>≥18a</c:v>
                </c:pt>
                <c:pt idx="9">
                  <c:v>Medical care within the EB House Austria in the past 12 months      &lt; 18</c:v>
                </c:pt>
                <c:pt idx="10">
                  <c:v>≥18a</c:v>
                </c:pt>
                <c:pt idx="12">
                  <c:v>Knowledge about worldwide clinical trials for EB       &lt; 18</c:v>
                </c:pt>
                <c:pt idx="13">
                  <c:v>≥18a</c:v>
                </c:pt>
                <c:pt idx="15">
                  <c:v>Knowledge about clinical trials in the EB House Austria       &lt; 18</c:v>
                </c:pt>
                <c:pt idx="16">
                  <c:v>≥18a</c:v>
                </c:pt>
                <c:pt idx="18">
                  <c:v>Desire for more information about clinical studies       &lt; 18</c:v>
                </c:pt>
                <c:pt idx="19">
                  <c:v>≥18a</c:v>
                </c:pt>
                <c:pt idx="21">
                  <c:v>Willingness to persuade other patients to participate in a clinical trial       &lt; 18</c:v>
                </c:pt>
                <c:pt idx="22">
                  <c:v>≥18a</c:v>
                </c:pt>
                <c:pt idx="24">
                  <c:v>*Willingness to participate in clinical studies       &lt; 18</c:v>
                </c:pt>
                <c:pt idx="25">
                  <c:v>≥18a</c:v>
                </c:pt>
                <c:pt idx="27">
                  <c:v>*Desire for better treatment options       &lt; 18</c:v>
                </c:pt>
                <c:pt idx="28">
                  <c:v>≥18a</c:v>
                </c:pt>
                <c:pt idx="30">
                  <c:v>Hope for improved QoL within the next 5-10 years through new therapies      &lt; 18</c:v>
                </c:pt>
                <c:pt idx="31">
                  <c:v>≥18a</c:v>
                </c:pt>
              </c:strCache>
            </c:strRef>
          </c:cat>
          <c:val>
            <c:numRef>
              <c:f>'subgroup young old'!$D$24:$AI$24</c:f>
              <c:numCache>
                <c:formatCode>###0</c:formatCode>
                <c:ptCount val="32"/>
                <c:pt idx="0">
                  <c:v>8</c:v>
                </c:pt>
                <c:pt idx="1">
                  <c:v>9</c:v>
                </c:pt>
                <c:pt idx="3">
                  <c:v>9</c:v>
                </c:pt>
                <c:pt idx="4">
                  <c:v>6</c:v>
                </c:pt>
                <c:pt idx="6" formatCode="General">
                  <c:v>8</c:v>
                </c:pt>
                <c:pt idx="7" formatCode="General">
                  <c:v>4</c:v>
                </c:pt>
                <c:pt idx="9" formatCode="General">
                  <c:v>6</c:v>
                </c:pt>
                <c:pt idx="10" formatCode="General">
                  <c:v>3</c:v>
                </c:pt>
                <c:pt idx="12" formatCode="General">
                  <c:v>4</c:v>
                </c:pt>
                <c:pt idx="13" formatCode="General">
                  <c:v>6</c:v>
                </c:pt>
                <c:pt idx="15" formatCode="General">
                  <c:v>6</c:v>
                </c:pt>
                <c:pt idx="16" formatCode="General">
                  <c:v>5</c:v>
                </c:pt>
                <c:pt idx="18" formatCode="General">
                  <c:v>1</c:v>
                </c:pt>
                <c:pt idx="19" formatCode="General">
                  <c:v>5</c:v>
                </c:pt>
                <c:pt idx="21" formatCode="General">
                  <c:v>5</c:v>
                </c:pt>
                <c:pt idx="22" formatCode="General">
                  <c:v>1</c:v>
                </c:pt>
                <c:pt idx="24" formatCode="General">
                  <c:v>5</c:v>
                </c:pt>
                <c:pt idx="25" formatCode="General">
                  <c:v>2</c:v>
                </c:pt>
                <c:pt idx="27" formatCode="General">
                  <c:v>2</c:v>
                </c:pt>
                <c:pt idx="28" formatCode="General">
                  <c:v>1</c:v>
                </c:pt>
                <c:pt idx="30" formatCode="General">
                  <c:v>2</c:v>
                </c:pt>
                <c:pt idx="31" formatCode="General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F-47FC-4413-8773-059E1E8C12BC}"/>
            </c:ext>
          </c:extLst>
        </c:ser>
        <c:ser>
          <c:idx val="4"/>
          <c:order val="4"/>
          <c:tx>
            <c:v>5 - very good/high</c:v>
          </c:tx>
          <c:spPr>
            <a:solidFill>
              <a:srgbClr val="009900"/>
            </a:solidFill>
            <a:ln>
              <a:noFill/>
            </a:ln>
            <a:effectLst/>
          </c:spPr>
          <c:invertIfNegative val="0"/>
          <c:dLbls>
            <c:dLbl>
              <c:idx val="12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0-47FC-4413-8773-059E1E8C12BC}"/>
                </c:ext>
              </c:extLst>
            </c:dLbl>
            <c:dLbl>
              <c:idx val="15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1-47FC-4413-8773-059E1E8C12BC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50" b="1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ubgroup young old'!$D$20:$AI$20</c:f>
              <c:strCache>
                <c:ptCount val="32"/>
                <c:pt idx="0">
                  <c:v>Quality of Life in the past 12 months         &lt; 18</c:v>
                </c:pt>
                <c:pt idx="1">
                  <c:v>≥18a</c:v>
                </c:pt>
                <c:pt idx="3">
                  <c:v>Health status in the past 12 months      &lt; 18</c:v>
                </c:pt>
                <c:pt idx="4">
                  <c:v>≥18a</c:v>
                </c:pt>
                <c:pt idx="6">
                  <c:v>Medical care outside EB House Austria in the past 12 months        &lt; 18</c:v>
                </c:pt>
                <c:pt idx="7">
                  <c:v>≥18a</c:v>
                </c:pt>
                <c:pt idx="9">
                  <c:v>Medical care within the EB House Austria in the past 12 months      &lt; 18</c:v>
                </c:pt>
                <c:pt idx="10">
                  <c:v>≥18a</c:v>
                </c:pt>
                <c:pt idx="12">
                  <c:v>Knowledge about worldwide clinical trials for EB       &lt; 18</c:v>
                </c:pt>
                <c:pt idx="13">
                  <c:v>≥18a</c:v>
                </c:pt>
                <c:pt idx="15">
                  <c:v>Knowledge about clinical trials in the EB House Austria       &lt; 18</c:v>
                </c:pt>
                <c:pt idx="16">
                  <c:v>≥18a</c:v>
                </c:pt>
                <c:pt idx="18">
                  <c:v>Desire for more information about clinical studies       &lt; 18</c:v>
                </c:pt>
                <c:pt idx="19">
                  <c:v>≥18a</c:v>
                </c:pt>
                <c:pt idx="21">
                  <c:v>Willingness to persuade other patients to participate in a clinical trial       &lt; 18</c:v>
                </c:pt>
                <c:pt idx="22">
                  <c:v>≥18a</c:v>
                </c:pt>
                <c:pt idx="24">
                  <c:v>*Willingness to participate in clinical studies       &lt; 18</c:v>
                </c:pt>
                <c:pt idx="25">
                  <c:v>≥18a</c:v>
                </c:pt>
                <c:pt idx="27">
                  <c:v>*Desire for better treatment options       &lt; 18</c:v>
                </c:pt>
                <c:pt idx="28">
                  <c:v>≥18a</c:v>
                </c:pt>
                <c:pt idx="30">
                  <c:v>Hope for improved QoL within the next 5-10 years through new therapies      &lt; 18</c:v>
                </c:pt>
                <c:pt idx="31">
                  <c:v>≥18a</c:v>
                </c:pt>
              </c:strCache>
            </c:strRef>
          </c:cat>
          <c:val>
            <c:numRef>
              <c:f>'subgroup young old'!$D$25:$AI$25</c:f>
              <c:numCache>
                <c:formatCode>###0</c:formatCode>
                <c:ptCount val="32"/>
                <c:pt idx="0">
                  <c:v>2</c:v>
                </c:pt>
                <c:pt idx="1">
                  <c:v>6</c:v>
                </c:pt>
                <c:pt idx="3">
                  <c:v>1</c:v>
                </c:pt>
                <c:pt idx="4">
                  <c:v>4</c:v>
                </c:pt>
                <c:pt idx="6" formatCode="General">
                  <c:v>1</c:v>
                </c:pt>
                <c:pt idx="7" formatCode="General">
                  <c:v>7</c:v>
                </c:pt>
                <c:pt idx="9" formatCode="General">
                  <c:v>3</c:v>
                </c:pt>
                <c:pt idx="10" formatCode="General">
                  <c:v>13</c:v>
                </c:pt>
                <c:pt idx="13" formatCode="General">
                  <c:v>5</c:v>
                </c:pt>
                <c:pt idx="16" formatCode="General">
                  <c:v>3</c:v>
                </c:pt>
                <c:pt idx="18" formatCode="General">
                  <c:v>8</c:v>
                </c:pt>
                <c:pt idx="19" formatCode="General">
                  <c:v>6</c:v>
                </c:pt>
                <c:pt idx="21" formatCode="General">
                  <c:v>1</c:v>
                </c:pt>
                <c:pt idx="22" formatCode="General">
                  <c:v>2</c:v>
                </c:pt>
                <c:pt idx="24" formatCode="General">
                  <c:v>4</c:v>
                </c:pt>
                <c:pt idx="25" formatCode="General">
                  <c:v>6</c:v>
                </c:pt>
                <c:pt idx="27" formatCode="General">
                  <c:v>7</c:v>
                </c:pt>
                <c:pt idx="28" formatCode="General">
                  <c:v>5</c:v>
                </c:pt>
                <c:pt idx="30" formatCode="General">
                  <c:v>7</c:v>
                </c:pt>
                <c:pt idx="31" formatCode="General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2-47FC-4413-8773-059E1E8C12B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6"/>
        <c:overlap val="100"/>
        <c:axId val="610602080"/>
        <c:axId val="610606672"/>
      </c:barChart>
      <c:catAx>
        <c:axId val="610602080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spc="-8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0606672"/>
        <c:crosses val="autoZero"/>
        <c:auto val="1"/>
        <c:lblAlgn val="ctr"/>
        <c:lblOffset val="100"/>
        <c:noMultiLvlLbl val="0"/>
      </c:catAx>
      <c:valAx>
        <c:axId val="610606672"/>
        <c:scaling>
          <c:orientation val="minMax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0602080"/>
        <c:crosses val="autoZero"/>
        <c:crossBetween val="between"/>
        <c:majorUnit val="0.25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53042180691263441"/>
          <c:y val="0.95715997484667514"/>
          <c:w val="0.3786405284654093"/>
          <c:h val="3.243005682995699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400" b="0" i="0" baseline="0">
                <a:effectLst/>
              </a:rPr>
              <a:t>Subgroup 0-17 (young) and ≥ 18 (old) years of age</a:t>
            </a:r>
            <a:endParaRPr lang="en-US" sz="1050">
              <a:effectLst/>
            </a:endParaRPr>
          </a:p>
          <a:p>
            <a:pPr>
              <a:defRPr sz="1200"/>
            </a:pPr>
            <a:r>
              <a:rPr lang="en-US" sz="1200"/>
              <a:t>- Arguments</a:t>
            </a:r>
            <a:r>
              <a:rPr lang="en-US" sz="1200" baseline="0"/>
              <a:t> for participation in a clinical trial</a:t>
            </a:r>
            <a:endParaRPr lang="en-US" sz="120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48343913877014855"/>
          <c:y val="0.10448830488154569"/>
          <c:w val="0.43395505815055491"/>
          <c:h val="0.83979407817821183"/>
        </c:manualLayout>
      </c:layout>
      <c:barChart>
        <c:barDir val="bar"/>
        <c:grouping val="percentStacked"/>
        <c:varyColors val="0"/>
        <c:ser>
          <c:idx val="0"/>
          <c:order val="0"/>
          <c:tx>
            <c:v>1 - not at all important</c:v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dLbls>
            <c:dLbl>
              <c:idx val="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2995-4628-81FF-73F1FE05B413}"/>
                </c:ext>
              </c:extLst>
            </c:dLbl>
            <c:dLbl>
              <c:idx val="7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2995-4628-81FF-73F1FE05B413}"/>
                </c:ext>
              </c:extLst>
            </c:dLbl>
            <c:dLbl>
              <c:idx val="12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2995-4628-81FF-73F1FE05B413}"/>
                </c:ext>
              </c:extLst>
            </c:dLbl>
            <c:dLbl>
              <c:idx val="15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2995-4628-81FF-73F1FE05B413}"/>
                </c:ext>
              </c:extLst>
            </c:dLbl>
            <c:dLbl>
              <c:idx val="18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4-2995-4628-81FF-73F1FE05B413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50" b="1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ubgroup young old'!$AL$20:$BZ$20</c:f>
              <c:strCache>
                <c:ptCount val="41"/>
                <c:pt idx="0">
                  <c:v>Future improvement for other EB patients      &lt; 18</c:v>
                </c:pt>
                <c:pt idx="1">
                  <c:v>≥18a</c:v>
                </c:pt>
                <c:pt idx="3">
                  <c:v>Alleviation of own symptoms       &lt; 18</c:v>
                </c:pt>
                <c:pt idx="4">
                  <c:v>≥18a</c:v>
                </c:pt>
                <c:pt idx="6">
                  <c:v>Contribution to something important for the general welfare       &lt; 18</c:v>
                </c:pt>
                <c:pt idx="7">
                  <c:v>≥18a</c:v>
                </c:pt>
                <c:pt idx="9">
                  <c:v>Contribute to an increased knowledge about the disease       &lt; 18</c:v>
                </c:pt>
                <c:pt idx="10">
                  <c:v>≥18a</c:v>
                </c:pt>
                <c:pt idx="12">
                  <c:v>No additional expenses occur for participiants  (e.g. for travelling)       &lt; 18</c:v>
                </c:pt>
                <c:pt idx="13">
                  <c:v>≥18a</c:v>
                </c:pt>
                <c:pt idx="15">
                  <c:v>Study visits via telemedicine/ telephone       &lt; 18</c:v>
                </c:pt>
                <c:pt idx="16">
                  <c:v>≥18a</c:v>
                </c:pt>
                <c:pt idx="18">
                  <c:v>Being in the treatment group (rather than placebo group)       &lt; 18</c:v>
                </c:pt>
                <c:pt idx="19">
                  <c:v>≥18a</c:v>
                </c:pt>
                <c:pt idx="21">
                  <c:v>Study visit times consider patients' need and are flexible       &lt; 18</c:v>
                </c:pt>
                <c:pt idx="22">
                  <c:v>≥18a</c:v>
                </c:pt>
                <c:pt idx="24">
                  <c:v>Better medical care through increased frequency of visits      &lt; 18</c:v>
                </c:pt>
                <c:pt idx="25">
                  <c:v>≥18a</c:v>
                </c:pt>
                <c:pt idx="27">
                  <c:v>Receiving recommendations from my physician       &lt; 18</c:v>
                </c:pt>
                <c:pt idx="28">
                  <c:v>≥18a</c:v>
                </c:pt>
                <c:pt idx="30">
                  <c:v>Receiving recommendations from social network or online fores       &lt; 18</c:v>
                </c:pt>
                <c:pt idx="31">
                  <c:v>≥18a</c:v>
                </c:pt>
                <c:pt idx="33">
                  <c:v>Receiving recommendations from friends       &lt; 18</c:v>
                </c:pt>
                <c:pt idx="34">
                  <c:v>≥18a</c:v>
                </c:pt>
                <c:pt idx="36">
                  <c:v>Availability of a contact person from the study team night and day      &lt; 18</c:v>
                </c:pt>
                <c:pt idx="37">
                  <c:v>≥18a</c:v>
                </c:pt>
                <c:pt idx="39">
                  <c:v>Attractive rewards (e.g. ipad, camera) are offered       &lt; 18</c:v>
                </c:pt>
                <c:pt idx="40">
                  <c:v>≥18a</c:v>
                </c:pt>
              </c:strCache>
            </c:strRef>
          </c:cat>
          <c:val>
            <c:numRef>
              <c:f>'subgroup young old'!$AL$21:$BZ$21</c:f>
              <c:numCache>
                <c:formatCode>General</c:formatCode>
                <c:ptCount val="41"/>
                <c:pt idx="4" formatCode="###0">
                  <c:v>1</c:v>
                </c:pt>
                <c:pt idx="6">
                  <c:v>1</c:v>
                </c:pt>
                <c:pt idx="9">
                  <c:v>1</c:v>
                </c:pt>
                <c:pt idx="10">
                  <c:v>1</c:v>
                </c:pt>
                <c:pt idx="13" formatCode="###0">
                  <c:v>3</c:v>
                </c:pt>
                <c:pt idx="16" formatCode="###0">
                  <c:v>2</c:v>
                </c:pt>
                <c:pt idx="19" formatCode="###0">
                  <c:v>2</c:v>
                </c:pt>
                <c:pt idx="21" formatCode="###0">
                  <c:v>1</c:v>
                </c:pt>
                <c:pt idx="22" formatCode="###0">
                  <c:v>1</c:v>
                </c:pt>
                <c:pt idx="24" formatCode="###0">
                  <c:v>2</c:v>
                </c:pt>
                <c:pt idx="25" formatCode="###0">
                  <c:v>2</c:v>
                </c:pt>
                <c:pt idx="27" formatCode="###0">
                  <c:v>1</c:v>
                </c:pt>
                <c:pt idx="28" formatCode="###0">
                  <c:v>4</c:v>
                </c:pt>
                <c:pt idx="30" formatCode="###0">
                  <c:v>3</c:v>
                </c:pt>
                <c:pt idx="31" formatCode="###0">
                  <c:v>1</c:v>
                </c:pt>
                <c:pt idx="33" formatCode="###0">
                  <c:v>2</c:v>
                </c:pt>
                <c:pt idx="34" formatCode="###0">
                  <c:v>4</c:v>
                </c:pt>
                <c:pt idx="36" formatCode="###0">
                  <c:v>2</c:v>
                </c:pt>
                <c:pt idx="37" formatCode="###0">
                  <c:v>5</c:v>
                </c:pt>
                <c:pt idx="39" formatCode="###0">
                  <c:v>7</c:v>
                </c:pt>
                <c:pt idx="40" formatCode="###0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2995-4628-81FF-73F1FE05B413}"/>
            </c:ext>
          </c:extLst>
        </c:ser>
        <c:ser>
          <c:idx val="1"/>
          <c:order val="1"/>
          <c:tx>
            <c:v>2</c:v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dLbls>
            <c:dLbl>
              <c:idx val="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6-2995-4628-81FF-73F1FE05B413}"/>
                </c:ext>
              </c:extLst>
            </c:dLbl>
            <c:dLbl>
              <c:idx val="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2995-4628-81FF-73F1FE05B413}"/>
                </c:ext>
              </c:extLst>
            </c:dLbl>
            <c:dLbl>
              <c:idx val="1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8-2995-4628-81FF-73F1FE05B413}"/>
                </c:ext>
              </c:extLst>
            </c:dLbl>
            <c:dLbl>
              <c:idx val="16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2995-4628-81FF-73F1FE05B413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50" b="1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ubgroup young old'!$AL$20:$BZ$20</c:f>
              <c:strCache>
                <c:ptCount val="41"/>
                <c:pt idx="0">
                  <c:v>Future improvement for other EB patients      &lt; 18</c:v>
                </c:pt>
                <c:pt idx="1">
                  <c:v>≥18a</c:v>
                </c:pt>
                <c:pt idx="3">
                  <c:v>Alleviation of own symptoms       &lt; 18</c:v>
                </c:pt>
                <c:pt idx="4">
                  <c:v>≥18a</c:v>
                </c:pt>
                <c:pt idx="6">
                  <c:v>Contribution to something important for the general welfare       &lt; 18</c:v>
                </c:pt>
                <c:pt idx="7">
                  <c:v>≥18a</c:v>
                </c:pt>
                <c:pt idx="9">
                  <c:v>Contribute to an increased knowledge about the disease       &lt; 18</c:v>
                </c:pt>
                <c:pt idx="10">
                  <c:v>≥18a</c:v>
                </c:pt>
                <c:pt idx="12">
                  <c:v>No additional expenses occur for participiants  (e.g. for travelling)       &lt; 18</c:v>
                </c:pt>
                <c:pt idx="13">
                  <c:v>≥18a</c:v>
                </c:pt>
                <c:pt idx="15">
                  <c:v>Study visits via telemedicine/ telephone       &lt; 18</c:v>
                </c:pt>
                <c:pt idx="16">
                  <c:v>≥18a</c:v>
                </c:pt>
                <c:pt idx="18">
                  <c:v>Being in the treatment group (rather than placebo group)       &lt; 18</c:v>
                </c:pt>
                <c:pt idx="19">
                  <c:v>≥18a</c:v>
                </c:pt>
                <c:pt idx="21">
                  <c:v>Study visit times consider patients' need and are flexible       &lt; 18</c:v>
                </c:pt>
                <c:pt idx="22">
                  <c:v>≥18a</c:v>
                </c:pt>
                <c:pt idx="24">
                  <c:v>Better medical care through increased frequency of visits      &lt; 18</c:v>
                </c:pt>
                <c:pt idx="25">
                  <c:v>≥18a</c:v>
                </c:pt>
                <c:pt idx="27">
                  <c:v>Receiving recommendations from my physician       &lt; 18</c:v>
                </c:pt>
                <c:pt idx="28">
                  <c:v>≥18a</c:v>
                </c:pt>
                <c:pt idx="30">
                  <c:v>Receiving recommendations from social network or online fores       &lt; 18</c:v>
                </c:pt>
                <c:pt idx="31">
                  <c:v>≥18a</c:v>
                </c:pt>
                <c:pt idx="33">
                  <c:v>Receiving recommendations from friends       &lt; 18</c:v>
                </c:pt>
                <c:pt idx="34">
                  <c:v>≥18a</c:v>
                </c:pt>
                <c:pt idx="36">
                  <c:v>Availability of a contact person from the study team night and day      &lt; 18</c:v>
                </c:pt>
                <c:pt idx="37">
                  <c:v>≥18a</c:v>
                </c:pt>
                <c:pt idx="39">
                  <c:v>Attractive rewards (e.g. ipad, camera) are offered       &lt; 18</c:v>
                </c:pt>
                <c:pt idx="40">
                  <c:v>≥18a</c:v>
                </c:pt>
              </c:strCache>
            </c:strRef>
          </c:cat>
          <c:val>
            <c:numRef>
              <c:f>'subgroup young old'!$AL$22:$BZ$22</c:f>
              <c:numCache>
                <c:formatCode>###0</c:formatCode>
                <c:ptCount val="41"/>
                <c:pt idx="1">
                  <c:v>1</c:v>
                </c:pt>
                <c:pt idx="4">
                  <c:v>1</c:v>
                </c:pt>
                <c:pt idx="6" formatCode="General">
                  <c:v>2</c:v>
                </c:pt>
                <c:pt idx="7" formatCode="General">
                  <c:v>2</c:v>
                </c:pt>
                <c:pt idx="9" formatCode="General">
                  <c:v>1</c:v>
                </c:pt>
                <c:pt idx="10" formatCode="General">
                  <c:v>1</c:v>
                </c:pt>
                <c:pt idx="12">
                  <c:v>1</c:v>
                </c:pt>
                <c:pt idx="15">
                  <c:v>1</c:v>
                </c:pt>
                <c:pt idx="18">
                  <c:v>1</c:v>
                </c:pt>
                <c:pt idx="19">
                  <c:v>1</c:v>
                </c:pt>
                <c:pt idx="21">
                  <c:v>2</c:v>
                </c:pt>
                <c:pt idx="24">
                  <c:v>2</c:v>
                </c:pt>
                <c:pt idx="25">
                  <c:v>2</c:v>
                </c:pt>
                <c:pt idx="27">
                  <c:v>2</c:v>
                </c:pt>
                <c:pt idx="28">
                  <c:v>2</c:v>
                </c:pt>
                <c:pt idx="30">
                  <c:v>2</c:v>
                </c:pt>
                <c:pt idx="31">
                  <c:v>1</c:v>
                </c:pt>
                <c:pt idx="33">
                  <c:v>2</c:v>
                </c:pt>
                <c:pt idx="36">
                  <c:v>3</c:v>
                </c:pt>
                <c:pt idx="37">
                  <c:v>2</c:v>
                </c:pt>
                <c:pt idx="39">
                  <c:v>1</c:v>
                </c:pt>
                <c:pt idx="4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2995-4628-81FF-73F1FE05B413}"/>
            </c:ext>
          </c:extLst>
        </c:ser>
        <c:ser>
          <c:idx val="2"/>
          <c:order val="2"/>
          <c:tx>
            <c:v>3</c:v>
          </c:tx>
          <c:spPr>
            <a:solidFill>
              <a:schemeClr val="bg1">
                <a:lumMod val="85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2995-4628-81FF-73F1FE05B413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5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ubgroup young old'!$AL$20:$BZ$20</c:f>
              <c:strCache>
                <c:ptCount val="41"/>
                <c:pt idx="0">
                  <c:v>Future improvement for other EB patients      &lt; 18</c:v>
                </c:pt>
                <c:pt idx="1">
                  <c:v>≥18a</c:v>
                </c:pt>
                <c:pt idx="3">
                  <c:v>Alleviation of own symptoms       &lt; 18</c:v>
                </c:pt>
                <c:pt idx="4">
                  <c:v>≥18a</c:v>
                </c:pt>
                <c:pt idx="6">
                  <c:v>Contribution to something important for the general welfare       &lt; 18</c:v>
                </c:pt>
                <c:pt idx="7">
                  <c:v>≥18a</c:v>
                </c:pt>
                <c:pt idx="9">
                  <c:v>Contribute to an increased knowledge about the disease       &lt; 18</c:v>
                </c:pt>
                <c:pt idx="10">
                  <c:v>≥18a</c:v>
                </c:pt>
                <c:pt idx="12">
                  <c:v>No additional expenses occur for participiants  (e.g. for travelling)       &lt; 18</c:v>
                </c:pt>
                <c:pt idx="13">
                  <c:v>≥18a</c:v>
                </c:pt>
                <c:pt idx="15">
                  <c:v>Study visits via telemedicine/ telephone       &lt; 18</c:v>
                </c:pt>
                <c:pt idx="16">
                  <c:v>≥18a</c:v>
                </c:pt>
                <c:pt idx="18">
                  <c:v>Being in the treatment group (rather than placebo group)       &lt; 18</c:v>
                </c:pt>
                <c:pt idx="19">
                  <c:v>≥18a</c:v>
                </c:pt>
                <c:pt idx="21">
                  <c:v>Study visit times consider patients' need and are flexible       &lt; 18</c:v>
                </c:pt>
                <c:pt idx="22">
                  <c:v>≥18a</c:v>
                </c:pt>
                <c:pt idx="24">
                  <c:v>Better medical care through increased frequency of visits      &lt; 18</c:v>
                </c:pt>
                <c:pt idx="25">
                  <c:v>≥18a</c:v>
                </c:pt>
                <c:pt idx="27">
                  <c:v>Receiving recommendations from my physician       &lt; 18</c:v>
                </c:pt>
                <c:pt idx="28">
                  <c:v>≥18a</c:v>
                </c:pt>
                <c:pt idx="30">
                  <c:v>Receiving recommendations from social network or online fores       &lt; 18</c:v>
                </c:pt>
                <c:pt idx="31">
                  <c:v>≥18a</c:v>
                </c:pt>
                <c:pt idx="33">
                  <c:v>Receiving recommendations from friends       &lt; 18</c:v>
                </c:pt>
                <c:pt idx="34">
                  <c:v>≥18a</c:v>
                </c:pt>
                <c:pt idx="36">
                  <c:v>Availability of a contact person from the study team night and day      &lt; 18</c:v>
                </c:pt>
                <c:pt idx="37">
                  <c:v>≥18a</c:v>
                </c:pt>
                <c:pt idx="39">
                  <c:v>Attractive rewards (e.g. ipad, camera) are offered       &lt; 18</c:v>
                </c:pt>
                <c:pt idx="40">
                  <c:v>≥18a</c:v>
                </c:pt>
              </c:strCache>
            </c:strRef>
          </c:cat>
          <c:val>
            <c:numRef>
              <c:f>'subgroup young old'!$AL$23:$BZ$23</c:f>
              <c:numCache>
                <c:formatCode>###0</c:formatCode>
                <c:ptCount val="41"/>
                <c:pt idx="1">
                  <c:v>2</c:v>
                </c:pt>
                <c:pt idx="3">
                  <c:v>2</c:v>
                </c:pt>
                <c:pt idx="4">
                  <c:v>3</c:v>
                </c:pt>
                <c:pt idx="6">
                  <c:v>1</c:v>
                </c:pt>
                <c:pt idx="7" formatCode="General">
                  <c:v>3</c:v>
                </c:pt>
                <c:pt idx="10" formatCode="General">
                  <c:v>5</c:v>
                </c:pt>
                <c:pt idx="12">
                  <c:v>4</c:v>
                </c:pt>
                <c:pt idx="13">
                  <c:v>1</c:v>
                </c:pt>
                <c:pt idx="15">
                  <c:v>4</c:v>
                </c:pt>
                <c:pt idx="16">
                  <c:v>2</c:v>
                </c:pt>
                <c:pt idx="18">
                  <c:v>3</c:v>
                </c:pt>
                <c:pt idx="19">
                  <c:v>2</c:v>
                </c:pt>
                <c:pt idx="21">
                  <c:v>2</c:v>
                </c:pt>
                <c:pt idx="22">
                  <c:v>4</c:v>
                </c:pt>
                <c:pt idx="24">
                  <c:v>3</c:v>
                </c:pt>
                <c:pt idx="25">
                  <c:v>6</c:v>
                </c:pt>
                <c:pt idx="27">
                  <c:v>3</c:v>
                </c:pt>
                <c:pt idx="28">
                  <c:v>4</c:v>
                </c:pt>
                <c:pt idx="30">
                  <c:v>4</c:v>
                </c:pt>
                <c:pt idx="31">
                  <c:v>8</c:v>
                </c:pt>
                <c:pt idx="33">
                  <c:v>5</c:v>
                </c:pt>
                <c:pt idx="34">
                  <c:v>5</c:v>
                </c:pt>
                <c:pt idx="36">
                  <c:v>4</c:v>
                </c:pt>
                <c:pt idx="37">
                  <c:v>1</c:v>
                </c:pt>
                <c:pt idx="39">
                  <c:v>1</c:v>
                </c:pt>
                <c:pt idx="40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2995-4628-81FF-73F1FE05B413}"/>
            </c:ext>
          </c:extLst>
        </c:ser>
        <c:ser>
          <c:idx val="3"/>
          <c:order val="3"/>
          <c:tx>
            <c:v>4</c:v>
          </c:tx>
          <c:spPr>
            <a:solidFill>
              <a:srgbClr val="83BD5B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50" b="1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ubgroup young old'!$AL$20:$BZ$20</c:f>
              <c:strCache>
                <c:ptCount val="41"/>
                <c:pt idx="0">
                  <c:v>Future improvement for other EB patients      &lt; 18</c:v>
                </c:pt>
                <c:pt idx="1">
                  <c:v>≥18a</c:v>
                </c:pt>
                <c:pt idx="3">
                  <c:v>Alleviation of own symptoms       &lt; 18</c:v>
                </c:pt>
                <c:pt idx="4">
                  <c:v>≥18a</c:v>
                </c:pt>
                <c:pt idx="6">
                  <c:v>Contribution to something important for the general welfare       &lt; 18</c:v>
                </c:pt>
                <c:pt idx="7">
                  <c:v>≥18a</c:v>
                </c:pt>
                <c:pt idx="9">
                  <c:v>Contribute to an increased knowledge about the disease       &lt; 18</c:v>
                </c:pt>
                <c:pt idx="10">
                  <c:v>≥18a</c:v>
                </c:pt>
                <c:pt idx="12">
                  <c:v>No additional expenses occur for participiants  (e.g. for travelling)       &lt; 18</c:v>
                </c:pt>
                <c:pt idx="13">
                  <c:v>≥18a</c:v>
                </c:pt>
                <c:pt idx="15">
                  <c:v>Study visits via telemedicine/ telephone       &lt; 18</c:v>
                </c:pt>
                <c:pt idx="16">
                  <c:v>≥18a</c:v>
                </c:pt>
                <c:pt idx="18">
                  <c:v>Being in the treatment group (rather than placebo group)       &lt; 18</c:v>
                </c:pt>
                <c:pt idx="19">
                  <c:v>≥18a</c:v>
                </c:pt>
                <c:pt idx="21">
                  <c:v>Study visit times consider patients' need and are flexible       &lt; 18</c:v>
                </c:pt>
                <c:pt idx="22">
                  <c:v>≥18a</c:v>
                </c:pt>
                <c:pt idx="24">
                  <c:v>Better medical care through increased frequency of visits      &lt; 18</c:v>
                </c:pt>
                <c:pt idx="25">
                  <c:v>≥18a</c:v>
                </c:pt>
                <c:pt idx="27">
                  <c:v>Receiving recommendations from my physician       &lt; 18</c:v>
                </c:pt>
                <c:pt idx="28">
                  <c:v>≥18a</c:v>
                </c:pt>
                <c:pt idx="30">
                  <c:v>Receiving recommendations from social network or online fores       &lt; 18</c:v>
                </c:pt>
                <c:pt idx="31">
                  <c:v>≥18a</c:v>
                </c:pt>
                <c:pt idx="33">
                  <c:v>Receiving recommendations from friends       &lt; 18</c:v>
                </c:pt>
                <c:pt idx="34">
                  <c:v>≥18a</c:v>
                </c:pt>
                <c:pt idx="36">
                  <c:v>Availability of a contact person from the study team night and day      &lt; 18</c:v>
                </c:pt>
                <c:pt idx="37">
                  <c:v>≥18a</c:v>
                </c:pt>
                <c:pt idx="39">
                  <c:v>Attractive rewards (e.g. ipad, camera) are offered       &lt; 18</c:v>
                </c:pt>
                <c:pt idx="40">
                  <c:v>≥18a</c:v>
                </c:pt>
              </c:strCache>
            </c:strRef>
          </c:cat>
          <c:val>
            <c:numRef>
              <c:f>'subgroup young old'!$AL$24:$BZ$24</c:f>
              <c:numCache>
                <c:formatCode>###0</c:formatCode>
                <c:ptCount val="41"/>
                <c:pt idx="0">
                  <c:v>3</c:v>
                </c:pt>
                <c:pt idx="1">
                  <c:v>1</c:v>
                </c:pt>
                <c:pt idx="3">
                  <c:v>1</c:v>
                </c:pt>
                <c:pt idx="4">
                  <c:v>2</c:v>
                </c:pt>
                <c:pt idx="7" formatCode="General">
                  <c:v>6</c:v>
                </c:pt>
                <c:pt idx="9" formatCode="General">
                  <c:v>4</c:v>
                </c:pt>
                <c:pt idx="10" formatCode="General">
                  <c:v>2</c:v>
                </c:pt>
                <c:pt idx="12">
                  <c:v>5</c:v>
                </c:pt>
                <c:pt idx="13">
                  <c:v>2</c:v>
                </c:pt>
                <c:pt idx="15">
                  <c:v>4</c:v>
                </c:pt>
                <c:pt idx="16">
                  <c:v>5</c:v>
                </c:pt>
                <c:pt idx="18">
                  <c:v>2</c:v>
                </c:pt>
                <c:pt idx="19">
                  <c:v>5</c:v>
                </c:pt>
                <c:pt idx="21">
                  <c:v>3</c:v>
                </c:pt>
                <c:pt idx="22">
                  <c:v>7</c:v>
                </c:pt>
                <c:pt idx="25">
                  <c:v>3</c:v>
                </c:pt>
                <c:pt idx="27">
                  <c:v>4</c:v>
                </c:pt>
                <c:pt idx="28">
                  <c:v>2</c:v>
                </c:pt>
                <c:pt idx="30">
                  <c:v>2</c:v>
                </c:pt>
                <c:pt idx="31">
                  <c:v>2</c:v>
                </c:pt>
                <c:pt idx="33">
                  <c:v>3</c:v>
                </c:pt>
                <c:pt idx="34">
                  <c:v>4</c:v>
                </c:pt>
                <c:pt idx="36">
                  <c:v>2</c:v>
                </c:pt>
                <c:pt idx="37">
                  <c:v>3</c:v>
                </c:pt>
                <c:pt idx="39">
                  <c:v>1</c:v>
                </c:pt>
                <c:pt idx="4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2995-4628-81FF-73F1FE05B413}"/>
            </c:ext>
          </c:extLst>
        </c:ser>
        <c:ser>
          <c:idx val="4"/>
          <c:order val="4"/>
          <c:tx>
            <c:v>5 - outmost important</c:v>
          </c:tx>
          <c:spPr>
            <a:solidFill>
              <a:srgbClr val="00990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50" b="1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ubgroup young old'!$AL$20:$BZ$20</c:f>
              <c:strCache>
                <c:ptCount val="41"/>
                <c:pt idx="0">
                  <c:v>Future improvement for other EB patients      &lt; 18</c:v>
                </c:pt>
                <c:pt idx="1">
                  <c:v>≥18a</c:v>
                </c:pt>
                <c:pt idx="3">
                  <c:v>Alleviation of own symptoms       &lt; 18</c:v>
                </c:pt>
                <c:pt idx="4">
                  <c:v>≥18a</c:v>
                </c:pt>
                <c:pt idx="6">
                  <c:v>Contribution to something important for the general welfare       &lt; 18</c:v>
                </c:pt>
                <c:pt idx="7">
                  <c:v>≥18a</c:v>
                </c:pt>
                <c:pt idx="9">
                  <c:v>Contribute to an increased knowledge about the disease       &lt; 18</c:v>
                </c:pt>
                <c:pt idx="10">
                  <c:v>≥18a</c:v>
                </c:pt>
                <c:pt idx="12">
                  <c:v>No additional expenses occur for participiants  (e.g. for travelling)       &lt; 18</c:v>
                </c:pt>
                <c:pt idx="13">
                  <c:v>≥18a</c:v>
                </c:pt>
                <c:pt idx="15">
                  <c:v>Study visits via telemedicine/ telephone       &lt; 18</c:v>
                </c:pt>
                <c:pt idx="16">
                  <c:v>≥18a</c:v>
                </c:pt>
                <c:pt idx="18">
                  <c:v>Being in the treatment group (rather than placebo group)       &lt; 18</c:v>
                </c:pt>
                <c:pt idx="19">
                  <c:v>≥18a</c:v>
                </c:pt>
                <c:pt idx="21">
                  <c:v>Study visit times consider patients' need and are flexible       &lt; 18</c:v>
                </c:pt>
                <c:pt idx="22">
                  <c:v>≥18a</c:v>
                </c:pt>
                <c:pt idx="24">
                  <c:v>Better medical care through increased frequency of visits      &lt; 18</c:v>
                </c:pt>
                <c:pt idx="25">
                  <c:v>≥18a</c:v>
                </c:pt>
                <c:pt idx="27">
                  <c:v>Receiving recommendations from my physician       &lt; 18</c:v>
                </c:pt>
                <c:pt idx="28">
                  <c:v>≥18a</c:v>
                </c:pt>
                <c:pt idx="30">
                  <c:v>Receiving recommendations from social network or online fores       &lt; 18</c:v>
                </c:pt>
                <c:pt idx="31">
                  <c:v>≥18a</c:v>
                </c:pt>
                <c:pt idx="33">
                  <c:v>Receiving recommendations from friends       &lt; 18</c:v>
                </c:pt>
                <c:pt idx="34">
                  <c:v>≥18a</c:v>
                </c:pt>
                <c:pt idx="36">
                  <c:v>Availability of a contact person from the study team night and day      &lt; 18</c:v>
                </c:pt>
                <c:pt idx="37">
                  <c:v>≥18a</c:v>
                </c:pt>
                <c:pt idx="39">
                  <c:v>Attractive rewards (e.g. ipad, camera) are offered       &lt; 18</c:v>
                </c:pt>
                <c:pt idx="40">
                  <c:v>≥18a</c:v>
                </c:pt>
              </c:strCache>
            </c:strRef>
          </c:cat>
          <c:val>
            <c:numRef>
              <c:f>'subgroup young old'!$AL$25:$BZ$25</c:f>
              <c:numCache>
                <c:formatCode>###0</c:formatCode>
                <c:ptCount val="41"/>
                <c:pt idx="0">
                  <c:v>9</c:v>
                </c:pt>
                <c:pt idx="1">
                  <c:v>11</c:v>
                </c:pt>
                <c:pt idx="3">
                  <c:v>9</c:v>
                </c:pt>
                <c:pt idx="4">
                  <c:v>7</c:v>
                </c:pt>
                <c:pt idx="6" formatCode="General">
                  <c:v>8</c:v>
                </c:pt>
                <c:pt idx="7" formatCode="General">
                  <c:v>4</c:v>
                </c:pt>
                <c:pt idx="9" formatCode="General">
                  <c:v>6</c:v>
                </c:pt>
                <c:pt idx="10" formatCode="General">
                  <c:v>6</c:v>
                </c:pt>
                <c:pt idx="12">
                  <c:v>2</c:v>
                </c:pt>
                <c:pt idx="13">
                  <c:v>9</c:v>
                </c:pt>
                <c:pt idx="15">
                  <c:v>3</c:v>
                </c:pt>
                <c:pt idx="16">
                  <c:v>6</c:v>
                </c:pt>
                <c:pt idx="18">
                  <c:v>6</c:v>
                </c:pt>
                <c:pt idx="19">
                  <c:v>4</c:v>
                </c:pt>
                <c:pt idx="21">
                  <c:v>4</c:v>
                </c:pt>
                <c:pt idx="22">
                  <c:v>4</c:v>
                </c:pt>
                <c:pt idx="24">
                  <c:v>5</c:v>
                </c:pt>
                <c:pt idx="25">
                  <c:v>2</c:v>
                </c:pt>
                <c:pt idx="27">
                  <c:v>2</c:v>
                </c:pt>
                <c:pt idx="28">
                  <c:v>2</c:v>
                </c:pt>
                <c:pt idx="30">
                  <c:v>1</c:v>
                </c:pt>
                <c:pt idx="31">
                  <c:v>2</c:v>
                </c:pt>
                <c:pt idx="34">
                  <c:v>2</c:v>
                </c:pt>
                <c:pt idx="37">
                  <c:v>4</c:v>
                </c:pt>
                <c:pt idx="39">
                  <c:v>1</c:v>
                </c:pt>
                <c:pt idx="40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2995-4628-81FF-73F1FE05B41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5"/>
        <c:overlap val="100"/>
        <c:axId val="548730424"/>
        <c:axId val="548731408"/>
      </c:barChart>
      <c:catAx>
        <c:axId val="548730424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spc="-7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48731408"/>
        <c:crosses val="autoZero"/>
        <c:auto val="1"/>
        <c:lblAlgn val="ctr"/>
        <c:lblOffset val="100"/>
        <c:noMultiLvlLbl val="0"/>
      </c:catAx>
      <c:valAx>
        <c:axId val="548731408"/>
        <c:scaling>
          <c:orientation val="minMax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48730424"/>
        <c:crosses val="autoZero"/>
        <c:crossBetween val="between"/>
        <c:majorUnit val="0.25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41560307212969749"/>
          <c:y val="0.96047633583509662"/>
          <c:w val="0.51253978472659933"/>
          <c:h val="2.383362324562072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Subgroup 0-17 (young) and ≥ 18 (old) years of age</a:t>
            </a:r>
          </a:p>
          <a:p>
            <a:pPr>
              <a:defRPr/>
            </a:pPr>
            <a:r>
              <a:rPr lang="en-US"/>
              <a:t>- Arguments against participation in a clinical trial</a:t>
            </a:r>
          </a:p>
          <a:p>
            <a:pPr>
              <a:defRPr/>
            </a:pPr>
            <a:endParaRPr lang="en-US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4303583729989785"/>
          <c:y val="0.12130592627558684"/>
          <c:w val="0.31649954011601028"/>
          <c:h val="0.82946275872920516"/>
        </c:manualLayout>
      </c:layout>
      <c:barChart>
        <c:barDir val="bar"/>
        <c:grouping val="percentStacked"/>
        <c:varyColors val="0"/>
        <c:ser>
          <c:idx val="0"/>
          <c:order val="0"/>
          <c:tx>
            <c:v>1 - not at all important</c:v>
          </c:tx>
          <c:spPr>
            <a:solidFill>
              <a:srgbClr val="00990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50" b="1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ubgroup young old'!$CD$20:$DL$20</c:f>
              <c:strCache>
                <c:ptCount val="35"/>
                <c:pt idx="0">
                  <c:v>Distance of the study center       &lt; 18</c:v>
                </c:pt>
                <c:pt idx="1">
                  <c:v>≥18a</c:v>
                </c:pt>
                <c:pt idx="3">
                  <c:v>Personal financial expenditures and incompatibility with occupational obligations       &lt; 18</c:v>
                </c:pt>
                <c:pt idx="4">
                  <c:v>≥18a</c:v>
                </c:pt>
                <c:pt idx="6">
                  <c:v>Extent of possible adverse reactions or unknown risk of the study medication       &lt; 18</c:v>
                </c:pt>
                <c:pt idx="7">
                  <c:v>≥18a</c:v>
                </c:pt>
                <c:pt idx="9">
                  <c:v>*Failure to meet the inclusion criteria       &lt; 18</c:v>
                </c:pt>
                <c:pt idx="10">
                  <c:v>≥18a</c:v>
                </c:pt>
                <c:pt idx="12">
                  <c:v>Medication not addressing the most important complaint       &lt; 18</c:v>
                </c:pt>
                <c:pt idx="13">
                  <c:v>≥18a</c:v>
                </c:pt>
                <c:pt idx="15">
                  <c:v>Extent of scheduled invasive investigations (e.g. blood taking, biopsy)       &lt; 18</c:v>
                </c:pt>
                <c:pt idx="16">
                  <c:v>≥18a</c:v>
                </c:pt>
                <c:pt idx="18">
                  <c:v>Need to daily document complaints       &lt; 18</c:v>
                </c:pt>
                <c:pt idx="19">
                  <c:v>≥18a</c:v>
                </c:pt>
                <c:pt idx="21">
                  <c:v>Need to stop the familial symptomatic treatment       &lt; 18</c:v>
                </c:pt>
                <c:pt idx="22">
                  <c:v>≥18a</c:v>
                </c:pt>
                <c:pt idx="24">
                  <c:v>Adverse personal circumstances       &lt; 18</c:v>
                </c:pt>
                <c:pt idx="25">
                  <c:v>≥18a</c:v>
                </c:pt>
                <c:pt idx="27">
                  <c:v>Extent and comprehensibility of informed consent paper       &lt; 18</c:v>
                </c:pt>
                <c:pt idx="28">
                  <c:v>≥18a</c:v>
                </c:pt>
                <c:pt idx="30">
                  <c:v>Negative experiences from other participants       &lt; 18</c:v>
                </c:pt>
                <c:pt idx="31">
                  <c:v>≥18a</c:v>
                </c:pt>
                <c:pt idx="33">
                  <c:v>Negative experiences made in previous studies       &lt; 18</c:v>
                </c:pt>
                <c:pt idx="34">
                  <c:v>≥18a</c:v>
                </c:pt>
              </c:strCache>
            </c:strRef>
          </c:cat>
          <c:val>
            <c:numRef>
              <c:f>'subgroup young old'!$CD$21:$DL$21</c:f>
              <c:numCache>
                <c:formatCode>###0</c:formatCode>
                <c:ptCount val="35"/>
                <c:pt idx="0">
                  <c:v>2</c:v>
                </c:pt>
                <c:pt idx="1">
                  <c:v>4</c:v>
                </c:pt>
                <c:pt idx="3">
                  <c:v>4</c:v>
                </c:pt>
                <c:pt idx="4">
                  <c:v>2</c:v>
                </c:pt>
                <c:pt idx="7">
                  <c:v>3</c:v>
                </c:pt>
                <c:pt idx="9">
                  <c:v>4</c:v>
                </c:pt>
                <c:pt idx="10">
                  <c:v>4</c:v>
                </c:pt>
                <c:pt idx="12">
                  <c:v>2</c:v>
                </c:pt>
                <c:pt idx="13">
                  <c:v>5</c:v>
                </c:pt>
                <c:pt idx="15">
                  <c:v>2</c:v>
                </c:pt>
                <c:pt idx="16">
                  <c:v>6</c:v>
                </c:pt>
                <c:pt idx="18">
                  <c:v>5</c:v>
                </c:pt>
                <c:pt idx="19">
                  <c:v>5</c:v>
                </c:pt>
                <c:pt idx="21">
                  <c:v>6</c:v>
                </c:pt>
                <c:pt idx="22">
                  <c:v>8</c:v>
                </c:pt>
                <c:pt idx="24">
                  <c:v>9</c:v>
                </c:pt>
                <c:pt idx="25">
                  <c:v>4</c:v>
                </c:pt>
                <c:pt idx="27">
                  <c:v>7</c:v>
                </c:pt>
                <c:pt idx="28">
                  <c:v>8</c:v>
                </c:pt>
                <c:pt idx="30">
                  <c:v>9</c:v>
                </c:pt>
                <c:pt idx="31">
                  <c:v>8</c:v>
                </c:pt>
                <c:pt idx="33">
                  <c:v>9</c:v>
                </c:pt>
                <c:pt idx="34">
                  <c:v>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681-41EE-AF22-59DD0A24726B}"/>
            </c:ext>
          </c:extLst>
        </c:ser>
        <c:ser>
          <c:idx val="1"/>
          <c:order val="1"/>
          <c:tx>
            <c:v>2</c:v>
          </c:tx>
          <c:spPr>
            <a:solidFill>
              <a:srgbClr val="83BD5B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50" b="1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ubgroup young old'!$CD$20:$DL$20</c:f>
              <c:strCache>
                <c:ptCount val="35"/>
                <c:pt idx="0">
                  <c:v>Distance of the study center       &lt; 18</c:v>
                </c:pt>
                <c:pt idx="1">
                  <c:v>≥18a</c:v>
                </c:pt>
                <c:pt idx="3">
                  <c:v>Personal financial expenditures and incompatibility with occupational obligations       &lt; 18</c:v>
                </c:pt>
                <c:pt idx="4">
                  <c:v>≥18a</c:v>
                </c:pt>
                <c:pt idx="6">
                  <c:v>Extent of possible adverse reactions or unknown risk of the study medication       &lt; 18</c:v>
                </c:pt>
                <c:pt idx="7">
                  <c:v>≥18a</c:v>
                </c:pt>
                <c:pt idx="9">
                  <c:v>*Failure to meet the inclusion criteria       &lt; 18</c:v>
                </c:pt>
                <c:pt idx="10">
                  <c:v>≥18a</c:v>
                </c:pt>
                <c:pt idx="12">
                  <c:v>Medication not addressing the most important complaint       &lt; 18</c:v>
                </c:pt>
                <c:pt idx="13">
                  <c:v>≥18a</c:v>
                </c:pt>
                <c:pt idx="15">
                  <c:v>Extent of scheduled invasive investigations (e.g. blood taking, biopsy)       &lt; 18</c:v>
                </c:pt>
                <c:pt idx="16">
                  <c:v>≥18a</c:v>
                </c:pt>
                <c:pt idx="18">
                  <c:v>Need to daily document complaints       &lt; 18</c:v>
                </c:pt>
                <c:pt idx="19">
                  <c:v>≥18a</c:v>
                </c:pt>
                <c:pt idx="21">
                  <c:v>Need to stop the familial symptomatic treatment       &lt; 18</c:v>
                </c:pt>
                <c:pt idx="22">
                  <c:v>≥18a</c:v>
                </c:pt>
                <c:pt idx="24">
                  <c:v>Adverse personal circumstances       &lt; 18</c:v>
                </c:pt>
                <c:pt idx="25">
                  <c:v>≥18a</c:v>
                </c:pt>
                <c:pt idx="27">
                  <c:v>Extent and comprehensibility of informed consent paper       &lt; 18</c:v>
                </c:pt>
                <c:pt idx="28">
                  <c:v>≥18a</c:v>
                </c:pt>
                <c:pt idx="30">
                  <c:v>Negative experiences from other participants       &lt; 18</c:v>
                </c:pt>
                <c:pt idx="31">
                  <c:v>≥18a</c:v>
                </c:pt>
                <c:pt idx="33">
                  <c:v>Negative experiences made in previous studies       &lt; 18</c:v>
                </c:pt>
                <c:pt idx="34">
                  <c:v>≥18a</c:v>
                </c:pt>
              </c:strCache>
            </c:strRef>
          </c:cat>
          <c:val>
            <c:numRef>
              <c:f>'subgroup young old'!$CD$22:$DL$22</c:f>
              <c:numCache>
                <c:formatCode>###0</c:formatCode>
                <c:ptCount val="35"/>
                <c:pt idx="0">
                  <c:v>1</c:v>
                </c:pt>
                <c:pt idx="4">
                  <c:v>2</c:v>
                </c:pt>
                <c:pt idx="6">
                  <c:v>2</c:v>
                </c:pt>
                <c:pt idx="7">
                  <c:v>5</c:v>
                </c:pt>
                <c:pt idx="9">
                  <c:v>1</c:v>
                </c:pt>
                <c:pt idx="12">
                  <c:v>2</c:v>
                </c:pt>
                <c:pt idx="13">
                  <c:v>1</c:v>
                </c:pt>
                <c:pt idx="18">
                  <c:v>1</c:v>
                </c:pt>
                <c:pt idx="19">
                  <c:v>2</c:v>
                </c:pt>
                <c:pt idx="21">
                  <c:v>3</c:v>
                </c:pt>
                <c:pt idx="22">
                  <c:v>2</c:v>
                </c:pt>
                <c:pt idx="25">
                  <c:v>2</c:v>
                </c:pt>
                <c:pt idx="27">
                  <c:v>2</c:v>
                </c:pt>
                <c:pt idx="28">
                  <c:v>3</c:v>
                </c:pt>
                <c:pt idx="30">
                  <c:v>3</c:v>
                </c:pt>
                <c:pt idx="31">
                  <c:v>3</c:v>
                </c:pt>
                <c:pt idx="34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681-41EE-AF22-59DD0A24726B}"/>
            </c:ext>
          </c:extLst>
        </c:ser>
        <c:ser>
          <c:idx val="2"/>
          <c:order val="2"/>
          <c:tx>
            <c:v>3</c:v>
          </c:tx>
          <c:spPr>
            <a:solidFill>
              <a:schemeClr val="bg1">
                <a:lumMod val="8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5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ubgroup young old'!$CD$20:$DL$20</c:f>
              <c:strCache>
                <c:ptCount val="35"/>
                <c:pt idx="0">
                  <c:v>Distance of the study center       &lt; 18</c:v>
                </c:pt>
                <c:pt idx="1">
                  <c:v>≥18a</c:v>
                </c:pt>
                <c:pt idx="3">
                  <c:v>Personal financial expenditures and incompatibility with occupational obligations       &lt; 18</c:v>
                </c:pt>
                <c:pt idx="4">
                  <c:v>≥18a</c:v>
                </c:pt>
                <c:pt idx="6">
                  <c:v>Extent of possible adverse reactions or unknown risk of the study medication       &lt; 18</c:v>
                </c:pt>
                <c:pt idx="7">
                  <c:v>≥18a</c:v>
                </c:pt>
                <c:pt idx="9">
                  <c:v>*Failure to meet the inclusion criteria       &lt; 18</c:v>
                </c:pt>
                <c:pt idx="10">
                  <c:v>≥18a</c:v>
                </c:pt>
                <c:pt idx="12">
                  <c:v>Medication not addressing the most important complaint       &lt; 18</c:v>
                </c:pt>
                <c:pt idx="13">
                  <c:v>≥18a</c:v>
                </c:pt>
                <c:pt idx="15">
                  <c:v>Extent of scheduled invasive investigations (e.g. blood taking, biopsy)       &lt; 18</c:v>
                </c:pt>
                <c:pt idx="16">
                  <c:v>≥18a</c:v>
                </c:pt>
                <c:pt idx="18">
                  <c:v>Need to daily document complaints       &lt; 18</c:v>
                </c:pt>
                <c:pt idx="19">
                  <c:v>≥18a</c:v>
                </c:pt>
                <c:pt idx="21">
                  <c:v>Need to stop the familial symptomatic treatment       &lt; 18</c:v>
                </c:pt>
                <c:pt idx="22">
                  <c:v>≥18a</c:v>
                </c:pt>
                <c:pt idx="24">
                  <c:v>Adverse personal circumstances       &lt; 18</c:v>
                </c:pt>
                <c:pt idx="25">
                  <c:v>≥18a</c:v>
                </c:pt>
                <c:pt idx="27">
                  <c:v>Extent and comprehensibility of informed consent paper       &lt; 18</c:v>
                </c:pt>
                <c:pt idx="28">
                  <c:v>≥18a</c:v>
                </c:pt>
                <c:pt idx="30">
                  <c:v>Negative experiences from other participants       &lt; 18</c:v>
                </c:pt>
                <c:pt idx="31">
                  <c:v>≥18a</c:v>
                </c:pt>
                <c:pt idx="33">
                  <c:v>Negative experiences made in previous studies       &lt; 18</c:v>
                </c:pt>
                <c:pt idx="34">
                  <c:v>≥18a</c:v>
                </c:pt>
              </c:strCache>
            </c:strRef>
          </c:cat>
          <c:val>
            <c:numRef>
              <c:f>'subgroup young old'!$CD$23:$DL$23</c:f>
              <c:numCache>
                <c:formatCode>###0</c:formatCode>
                <c:ptCount val="35"/>
                <c:pt idx="1">
                  <c:v>2</c:v>
                </c:pt>
                <c:pt idx="3">
                  <c:v>1</c:v>
                </c:pt>
                <c:pt idx="4">
                  <c:v>3</c:v>
                </c:pt>
                <c:pt idx="6">
                  <c:v>4</c:v>
                </c:pt>
                <c:pt idx="7">
                  <c:v>3</c:v>
                </c:pt>
                <c:pt idx="9">
                  <c:v>4</c:v>
                </c:pt>
                <c:pt idx="10">
                  <c:v>2</c:v>
                </c:pt>
                <c:pt idx="12">
                  <c:v>3</c:v>
                </c:pt>
                <c:pt idx="13">
                  <c:v>2</c:v>
                </c:pt>
                <c:pt idx="15">
                  <c:v>4</c:v>
                </c:pt>
                <c:pt idx="16">
                  <c:v>6</c:v>
                </c:pt>
                <c:pt idx="18">
                  <c:v>2</c:v>
                </c:pt>
                <c:pt idx="19">
                  <c:v>4</c:v>
                </c:pt>
                <c:pt idx="21">
                  <c:v>1</c:v>
                </c:pt>
                <c:pt idx="22">
                  <c:v>2</c:v>
                </c:pt>
                <c:pt idx="25">
                  <c:v>3</c:v>
                </c:pt>
                <c:pt idx="27">
                  <c:v>2</c:v>
                </c:pt>
                <c:pt idx="28">
                  <c:v>3</c:v>
                </c:pt>
                <c:pt idx="31">
                  <c:v>1</c:v>
                </c:pt>
                <c:pt idx="33">
                  <c:v>1</c:v>
                </c:pt>
                <c:pt idx="34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681-41EE-AF22-59DD0A24726B}"/>
            </c:ext>
          </c:extLst>
        </c:ser>
        <c:ser>
          <c:idx val="3"/>
          <c:order val="3"/>
          <c:tx>
            <c:v>4</c:v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50" b="1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ubgroup young old'!$CD$20:$DL$20</c:f>
              <c:strCache>
                <c:ptCount val="35"/>
                <c:pt idx="0">
                  <c:v>Distance of the study center       &lt; 18</c:v>
                </c:pt>
                <c:pt idx="1">
                  <c:v>≥18a</c:v>
                </c:pt>
                <c:pt idx="3">
                  <c:v>Personal financial expenditures and incompatibility with occupational obligations       &lt; 18</c:v>
                </c:pt>
                <c:pt idx="4">
                  <c:v>≥18a</c:v>
                </c:pt>
                <c:pt idx="6">
                  <c:v>Extent of possible adverse reactions or unknown risk of the study medication       &lt; 18</c:v>
                </c:pt>
                <c:pt idx="7">
                  <c:v>≥18a</c:v>
                </c:pt>
                <c:pt idx="9">
                  <c:v>*Failure to meet the inclusion criteria       &lt; 18</c:v>
                </c:pt>
                <c:pt idx="10">
                  <c:v>≥18a</c:v>
                </c:pt>
                <c:pt idx="12">
                  <c:v>Medication not addressing the most important complaint       &lt; 18</c:v>
                </c:pt>
                <c:pt idx="13">
                  <c:v>≥18a</c:v>
                </c:pt>
                <c:pt idx="15">
                  <c:v>Extent of scheduled invasive investigations (e.g. blood taking, biopsy)       &lt; 18</c:v>
                </c:pt>
                <c:pt idx="16">
                  <c:v>≥18a</c:v>
                </c:pt>
                <c:pt idx="18">
                  <c:v>Need to daily document complaints       &lt; 18</c:v>
                </c:pt>
                <c:pt idx="19">
                  <c:v>≥18a</c:v>
                </c:pt>
                <c:pt idx="21">
                  <c:v>Need to stop the familial symptomatic treatment       &lt; 18</c:v>
                </c:pt>
                <c:pt idx="22">
                  <c:v>≥18a</c:v>
                </c:pt>
                <c:pt idx="24">
                  <c:v>Adverse personal circumstances       &lt; 18</c:v>
                </c:pt>
                <c:pt idx="25">
                  <c:v>≥18a</c:v>
                </c:pt>
                <c:pt idx="27">
                  <c:v>Extent and comprehensibility of informed consent paper       &lt; 18</c:v>
                </c:pt>
                <c:pt idx="28">
                  <c:v>≥18a</c:v>
                </c:pt>
                <c:pt idx="30">
                  <c:v>Negative experiences from other participants       &lt; 18</c:v>
                </c:pt>
                <c:pt idx="31">
                  <c:v>≥18a</c:v>
                </c:pt>
                <c:pt idx="33">
                  <c:v>Negative experiences made in previous studies       &lt; 18</c:v>
                </c:pt>
                <c:pt idx="34">
                  <c:v>≥18a</c:v>
                </c:pt>
              </c:strCache>
            </c:strRef>
          </c:cat>
          <c:val>
            <c:numRef>
              <c:f>'subgroup young old'!$CD$24:$DL$24</c:f>
              <c:numCache>
                <c:formatCode>###0</c:formatCode>
                <c:ptCount val="35"/>
                <c:pt idx="0">
                  <c:v>3</c:v>
                </c:pt>
                <c:pt idx="1">
                  <c:v>2</c:v>
                </c:pt>
                <c:pt idx="3">
                  <c:v>4</c:v>
                </c:pt>
                <c:pt idx="4">
                  <c:v>2</c:v>
                </c:pt>
                <c:pt idx="6">
                  <c:v>3</c:v>
                </c:pt>
                <c:pt idx="7">
                  <c:v>1</c:v>
                </c:pt>
                <c:pt idx="10">
                  <c:v>2</c:v>
                </c:pt>
                <c:pt idx="12">
                  <c:v>3</c:v>
                </c:pt>
                <c:pt idx="13">
                  <c:v>7</c:v>
                </c:pt>
                <c:pt idx="15">
                  <c:v>2</c:v>
                </c:pt>
                <c:pt idx="16">
                  <c:v>1</c:v>
                </c:pt>
                <c:pt idx="18">
                  <c:v>4</c:v>
                </c:pt>
                <c:pt idx="19">
                  <c:v>2</c:v>
                </c:pt>
                <c:pt idx="21">
                  <c:v>2</c:v>
                </c:pt>
                <c:pt idx="22">
                  <c:v>4</c:v>
                </c:pt>
                <c:pt idx="24">
                  <c:v>2</c:v>
                </c:pt>
                <c:pt idx="31">
                  <c:v>1</c:v>
                </c:pt>
                <c:pt idx="3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681-41EE-AF22-59DD0A24726B}"/>
            </c:ext>
          </c:extLst>
        </c:ser>
        <c:ser>
          <c:idx val="4"/>
          <c:order val="4"/>
          <c:tx>
            <c:v>5 - outmost important</c:v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50" b="1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ubgroup young old'!$CD$20:$DL$20</c:f>
              <c:strCache>
                <c:ptCount val="35"/>
                <c:pt idx="0">
                  <c:v>Distance of the study center       &lt; 18</c:v>
                </c:pt>
                <c:pt idx="1">
                  <c:v>≥18a</c:v>
                </c:pt>
                <c:pt idx="3">
                  <c:v>Personal financial expenditures and incompatibility with occupational obligations       &lt; 18</c:v>
                </c:pt>
                <c:pt idx="4">
                  <c:v>≥18a</c:v>
                </c:pt>
                <c:pt idx="6">
                  <c:v>Extent of possible adverse reactions or unknown risk of the study medication       &lt; 18</c:v>
                </c:pt>
                <c:pt idx="7">
                  <c:v>≥18a</c:v>
                </c:pt>
                <c:pt idx="9">
                  <c:v>*Failure to meet the inclusion criteria       &lt; 18</c:v>
                </c:pt>
                <c:pt idx="10">
                  <c:v>≥18a</c:v>
                </c:pt>
                <c:pt idx="12">
                  <c:v>Medication not addressing the most important complaint       &lt; 18</c:v>
                </c:pt>
                <c:pt idx="13">
                  <c:v>≥18a</c:v>
                </c:pt>
                <c:pt idx="15">
                  <c:v>Extent of scheduled invasive investigations (e.g. blood taking, biopsy)       &lt; 18</c:v>
                </c:pt>
                <c:pt idx="16">
                  <c:v>≥18a</c:v>
                </c:pt>
                <c:pt idx="18">
                  <c:v>Need to daily document complaints       &lt; 18</c:v>
                </c:pt>
                <c:pt idx="19">
                  <c:v>≥18a</c:v>
                </c:pt>
                <c:pt idx="21">
                  <c:v>Need to stop the familial symptomatic treatment       &lt; 18</c:v>
                </c:pt>
                <c:pt idx="22">
                  <c:v>≥18a</c:v>
                </c:pt>
                <c:pt idx="24">
                  <c:v>Adverse personal circumstances       &lt; 18</c:v>
                </c:pt>
                <c:pt idx="25">
                  <c:v>≥18a</c:v>
                </c:pt>
                <c:pt idx="27">
                  <c:v>Extent and comprehensibility of informed consent paper       &lt; 18</c:v>
                </c:pt>
                <c:pt idx="28">
                  <c:v>≥18a</c:v>
                </c:pt>
                <c:pt idx="30">
                  <c:v>Negative experiences from other participants       &lt; 18</c:v>
                </c:pt>
                <c:pt idx="31">
                  <c:v>≥18a</c:v>
                </c:pt>
                <c:pt idx="33">
                  <c:v>Negative experiences made in previous studies       &lt; 18</c:v>
                </c:pt>
                <c:pt idx="34">
                  <c:v>≥18a</c:v>
                </c:pt>
              </c:strCache>
            </c:strRef>
          </c:cat>
          <c:val>
            <c:numRef>
              <c:f>'subgroup young old'!$CD$25:$DL$25</c:f>
              <c:numCache>
                <c:formatCode>###0</c:formatCode>
                <c:ptCount val="35"/>
                <c:pt idx="0">
                  <c:v>6</c:v>
                </c:pt>
                <c:pt idx="1">
                  <c:v>9</c:v>
                </c:pt>
                <c:pt idx="3">
                  <c:v>3</c:v>
                </c:pt>
                <c:pt idx="4">
                  <c:v>7</c:v>
                </c:pt>
                <c:pt idx="6">
                  <c:v>3</c:v>
                </c:pt>
                <c:pt idx="7">
                  <c:v>5</c:v>
                </c:pt>
                <c:pt idx="9">
                  <c:v>1</c:v>
                </c:pt>
                <c:pt idx="10">
                  <c:v>8</c:v>
                </c:pt>
                <c:pt idx="12">
                  <c:v>2</c:v>
                </c:pt>
                <c:pt idx="13">
                  <c:v>1</c:v>
                </c:pt>
                <c:pt idx="15">
                  <c:v>2</c:v>
                </c:pt>
                <c:pt idx="16">
                  <c:v>4</c:v>
                </c:pt>
                <c:pt idx="19">
                  <c:v>3</c:v>
                </c:pt>
                <c:pt idx="22">
                  <c:v>1</c:v>
                </c:pt>
                <c:pt idx="24">
                  <c:v>1</c:v>
                </c:pt>
                <c:pt idx="25">
                  <c:v>2</c:v>
                </c:pt>
                <c:pt idx="28">
                  <c:v>1</c:v>
                </c:pt>
                <c:pt idx="31">
                  <c:v>2</c:v>
                </c:pt>
                <c:pt idx="33">
                  <c:v>1</c:v>
                </c:pt>
                <c:pt idx="34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0681-41EE-AF22-59DD0A24726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6"/>
        <c:overlap val="100"/>
        <c:axId val="534045640"/>
        <c:axId val="534044328"/>
      </c:barChart>
      <c:catAx>
        <c:axId val="534045640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spc="-8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4044328"/>
        <c:crosses val="autoZero"/>
        <c:auto val="1"/>
        <c:lblAlgn val="ctr"/>
        <c:lblOffset val="100"/>
        <c:noMultiLvlLbl val="0"/>
      </c:catAx>
      <c:valAx>
        <c:axId val="534044328"/>
        <c:scaling>
          <c:orientation val="minMax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4045640"/>
        <c:crosses val="autoZero"/>
        <c:crossBetween val="between"/>
        <c:majorUnit val="0.25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9326466627696111"/>
          <c:y val="0.97101779742601657"/>
          <c:w val="0.35853140072254924"/>
          <c:h val="2.731468936207425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4A290-5F5B-4D77-B945-98732AC63554}" type="datetimeFigureOut">
              <a:rPr lang="en-US" smtClean="0"/>
              <a:t>5/3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8D7C43-78AD-4BA4-B4E2-322DCAF01D9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90621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4A290-5F5B-4D77-B945-98732AC63554}" type="datetimeFigureOut">
              <a:rPr lang="en-US" smtClean="0"/>
              <a:t>5/3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8D7C43-78AD-4BA4-B4E2-322DCAF01D9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39222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4A290-5F5B-4D77-B945-98732AC63554}" type="datetimeFigureOut">
              <a:rPr lang="en-US" smtClean="0"/>
              <a:t>5/3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8D7C43-78AD-4BA4-B4E2-322DCAF01D9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1111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4A290-5F5B-4D77-B945-98732AC63554}" type="datetimeFigureOut">
              <a:rPr lang="en-US" smtClean="0"/>
              <a:t>5/3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8D7C43-78AD-4BA4-B4E2-322DCAF01D9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0156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4A290-5F5B-4D77-B945-98732AC63554}" type="datetimeFigureOut">
              <a:rPr lang="en-US" smtClean="0"/>
              <a:t>5/3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8D7C43-78AD-4BA4-B4E2-322DCAF01D9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52977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4A290-5F5B-4D77-B945-98732AC63554}" type="datetimeFigureOut">
              <a:rPr lang="en-US" smtClean="0"/>
              <a:t>5/3/2020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8D7C43-78AD-4BA4-B4E2-322DCAF01D9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59409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4A290-5F5B-4D77-B945-98732AC63554}" type="datetimeFigureOut">
              <a:rPr lang="en-US" smtClean="0"/>
              <a:t>5/3/2020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8D7C43-78AD-4BA4-B4E2-322DCAF01D9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28476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4A290-5F5B-4D77-B945-98732AC63554}" type="datetimeFigureOut">
              <a:rPr lang="en-US" smtClean="0"/>
              <a:t>5/3/2020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8D7C43-78AD-4BA4-B4E2-322DCAF01D9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82662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4A290-5F5B-4D77-B945-98732AC63554}" type="datetimeFigureOut">
              <a:rPr lang="en-US" smtClean="0"/>
              <a:t>5/3/2020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8D7C43-78AD-4BA4-B4E2-322DCAF01D9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53964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4A290-5F5B-4D77-B945-98732AC63554}" type="datetimeFigureOut">
              <a:rPr lang="en-US" smtClean="0"/>
              <a:t>5/3/2020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8D7C43-78AD-4BA4-B4E2-322DCAF01D9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16353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4A290-5F5B-4D77-B945-98732AC63554}" type="datetimeFigureOut">
              <a:rPr lang="en-US" smtClean="0"/>
              <a:t>5/3/2020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8D7C43-78AD-4BA4-B4E2-322DCAF01D9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96678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D4A290-5F5B-4D77-B945-98732AC63554}" type="datetimeFigureOut">
              <a:rPr lang="en-US" smtClean="0"/>
              <a:t>5/3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8D7C43-78AD-4BA4-B4E2-322DCAF01D9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07326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Diagramm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76296127"/>
              </p:ext>
            </p:extLst>
          </p:nvPr>
        </p:nvGraphicFramePr>
        <p:xfrm>
          <a:off x="1417320" y="98230"/>
          <a:ext cx="9133294" cy="664089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8522507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Diagramm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15385308"/>
              </p:ext>
            </p:extLst>
          </p:nvPr>
        </p:nvGraphicFramePr>
        <p:xfrm>
          <a:off x="1719072" y="0"/>
          <a:ext cx="8618676" cy="685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9319039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Diagramm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34060055"/>
              </p:ext>
            </p:extLst>
          </p:nvPr>
        </p:nvGraphicFramePr>
        <p:xfrm>
          <a:off x="593555" y="0"/>
          <a:ext cx="11004889" cy="685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6091587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1</Words>
  <Application>Microsoft Office PowerPoint</Application>
  <PresentationFormat>Breitbild</PresentationFormat>
  <Paragraphs>6</Paragraphs>
  <Slides>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Christine</dc:creator>
  <cp:lastModifiedBy>Christine</cp:lastModifiedBy>
  <cp:revision>1</cp:revision>
  <dcterms:created xsi:type="dcterms:W3CDTF">2020-05-03T21:06:25Z</dcterms:created>
  <dcterms:modified xsi:type="dcterms:W3CDTF">2020-05-03T21:06:33Z</dcterms:modified>
</cp:coreProperties>
</file>